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152048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6" d="100"/>
          <a:sy n="56" d="100"/>
        </p:scale>
        <p:origin x="180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64037" y="1414125"/>
            <a:ext cx="9792415" cy="3008266"/>
          </a:xfrm>
        </p:spPr>
        <p:txBody>
          <a:bodyPr anchor="b"/>
          <a:lstStyle>
            <a:lvl1pPr algn="ctr">
              <a:defRPr sz="75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061" y="4538401"/>
            <a:ext cx="8640366" cy="2086184"/>
          </a:xfrm>
        </p:spPr>
        <p:txBody>
          <a:bodyPr/>
          <a:lstStyle>
            <a:lvl1pPr marL="0" indent="0" algn="ctr">
              <a:buNone/>
              <a:defRPr sz="3025"/>
            </a:lvl1pPr>
            <a:lvl2pPr marL="575945" indent="0" algn="ctr">
              <a:buNone/>
              <a:defRPr sz="2520"/>
            </a:lvl2pPr>
            <a:lvl3pPr marL="1151890" indent="0" algn="ctr">
              <a:buNone/>
              <a:defRPr sz="2270"/>
            </a:lvl3pPr>
            <a:lvl4pPr marL="1727835" indent="0" algn="ctr">
              <a:buNone/>
              <a:defRPr sz="2015"/>
            </a:lvl4pPr>
            <a:lvl5pPr marL="2304415" indent="0" algn="ctr">
              <a:buNone/>
              <a:defRPr sz="2015"/>
            </a:lvl5pPr>
            <a:lvl6pPr marL="2880360" indent="0" algn="ctr">
              <a:buNone/>
              <a:defRPr sz="2015"/>
            </a:lvl6pPr>
            <a:lvl7pPr marL="3456305" indent="0" algn="ctr">
              <a:buNone/>
              <a:defRPr sz="2015"/>
            </a:lvl7pPr>
            <a:lvl8pPr marL="4032250" indent="0" algn="ctr">
              <a:buNone/>
              <a:defRPr sz="2015"/>
            </a:lvl8pPr>
            <a:lvl9pPr marL="4608195" indent="0" algn="ctr">
              <a:buNone/>
              <a:defRPr sz="2015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244350" y="460041"/>
            <a:ext cx="2484105" cy="732264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92034" y="460041"/>
            <a:ext cx="7308310" cy="732264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6034" y="2154193"/>
            <a:ext cx="9936421" cy="3594317"/>
          </a:xfrm>
        </p:spPr>
        <p:txBody>
          <a:bodyPr anchor="b"/>
          <a:lstStyle>
            <a:lvl1pPr>
              <a:defRPr sz="756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6034" y="5782513"/>
            <a:ext cx="9936421" cy="1890166"/>
          </a:xfrm>
        </p:spPr>
        <p:txBody>
          <a:bodyPr/>
          <a:lstStyle>
            <a:lvl1pPr marL="0" indent="0">
              <a:buNone/>
              <a:defRPr sz="3025">
                <a:solidFill>
                  <a:schemeClr val="tx1">
                    <a:tint val="82000"/>
                  </a:schemeClr>
                </a:solidFill>
              </a:defRPr>
            </a:lvl1pPr>
            <a:lvl2pPr marL="575945" indent="0">
              <a:buNone/>
              <a:defRPr sz="2520">
                <a:solidFill>
                  <a:schemeClr val="tx1">
                    <a:tint val="82000"/>
                  </a:schemeClr>
                </a:solidFill>
              </a:defRPr>
            </a:lvl2pPr>
            <a:lvl3pPr marL="1151890" indent="0">
              <a:buNone/>
              <a:defRPr sz="2270">
                <a:solidFill>
                  <a:schemeClr val="tx1">
                    <a:tint val="82000"/>
                  </a:schemeClr>
                </a:solidFill>
              </a:defRPr>
            </a:lvl3pPr>
            <a:lvl4pPr marL="1727835" indent="0">
              <a:buNone/>
              <a:defRPr sz="2015">
                <a:solidFill>
                  <a:schemeClr val="tx1">
                    <a:tint val="82000"/>
                  </a:schemeClr>
                </a:solidFill>
              </a:defRPr>
            </a:lvl4pPr>
            <a:lvl5pPr marL="2304415" indent="0">
              <a:buNone/>
              <a:defRPr sz="2015">
                <a:solidFill>
                  <a:schemeClr val="tx1">
                    <a:tint val="82000"/>
                  </a:schemeClr>
                </a:solidFill>
              </a:defRPr>
            </a:lvl5pPr>
            <a:lvl6pPr marL="2880360" indent="0">
              <a:buNone/>
              <a:defRPr sz="2015">
                <a:solidFill>
                  <a:schemeClr val="tx1">
                    <a:tint val="82000"/>
                  </a:schemeClr>
                </a:solidFill>
              </a:defRPr>
            </a:lvl6pPr>
            <a:lvl7pPr marL="3456305" indent="0">
              <a:buNone/>
              <a:defRPr sz="2015">
                <a:solidFill>
                  <a:schemeClr val="tx1">
                    <a:tint val="82000"/>
                  </a:schemeClr>
                </a:solidFill>
              </a:defRPr>
            </a:lvl7pPr>
            <a:lvl8pPr marL="4032250" indent="0">
              <a:buNone/>
              <a:defRPr sz="2015">
                <a:solidFill>
                  <a:schemeClr val="tx1">
                    <a:tint val="82000"/>
                  </a:schemeClr>
                </a:solidFill>
              </a:defRPr>
            </a:lvl8pPr>
            <a:lvl9pPr marL="4608195" indent="0">
              <a:buNone/>
              <a:defRPr sz="2015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92034" y="2300203"/>
            <a:ext cx="4896207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832247" y="2300203"/>
            <a:ext cx="4896207" cy="548248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4" y="460043"/>
            <a:ext cx="9936421" cy="167014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3535" y="2118188"/>
            <a:ext cx="4873706" cy="1038091"/>
          </a:xfrm>
        </p:spPr>
        <p:txBody>
          <a:bodyPr anchor="b"/>
          <a:lstStyle>
            <a:lvl1pPr marL="0" indent="0">
              <a:buNone/>
              <a:defRPr sz="3025" b="1"/>
            </a:lvl1pPr>
            <a:lvl2pPr marL="575945" indent="0">
              <a:buNone/>
              <a:defRPr sz="2520" b="1"/>
            </a:lvl2pPr>
            <a:lvl3pPr marL="1151890" indent="0">
              <a:buNone/>
              <a:defRPr sz="2270" b="1"/>
            </a:lvl3pPr>
            <a:lvl4pPr marL="1727835" indent="0">
              <a:buNone/>
              <a:defRPr sz="2015" b="1"/>
            </a:lvl4pPr>
            <a:lvl5pPr marL="2304415" indent="0">
              <a:buNone/>
              <a:defRPr sz="2015" b="1"/>
            </a:lvl5pPr>
            <a:lvl6pPr marL="2880360" indent="0">
              <a:buNone/>
              <a:defRPr sz="2015" b="1"/>
            </a:lvl6pPr>
            <a:lvl7pPr marL="3456305" indent="0">
              <a:buNone/>
              <a:defRPr sz="2015" b="1"/>
            </a:lvl7pPr>
            <a:lvl8pPr marL="4032250" indent="0">
              <a:buNone/>
              <a:defRPr sz="2015" b="1"/>
            </a:lvl8pPr>
            <a:lvl9pPr marL="4608195" indent="0">
              <a:buNone/>
              <a:defRPr sz="201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93535" y="3156278"/>
            <a:ext cx="4873706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832248" y="2118188"/>
            <a:ext cx="4897708" cy="1038091"/>
          </a:xfrm>
        </p:spPr>
        <p:txBody>
          <a:bodyPr anchor="b"/>
          <a:lstStyle>
            <a:lvl1pPr marL="0" indent="0">
              <a:buNone/>
              <a:defRPr sz="3025" b="1"/>
            </a:lvl1pPr>
            <a:lvl2pPr marL="575945" indent="0">
              <a:buNone/>
              <a:defRPr sz="2520" b="1"/>
            </a:lvl2pPr>
            <a:lvl3pPr marL="1151890" indent="0">
              <a:buNone/>
              <a:defRPr sz="2270" b="1"/>
            </a:lvl3pPr>
            <a:lvl4pPr marL="1727835" indent="0">
              <a:buNone/>
              <a:defRPr sz="2015" b="1"/>
            </a:lvl4pPr>
            <a:lvl5pPr marL="2304415" indent="0">
              <a:buNone/>
              <a:defRPr sz="2015" b="1"/>
            </a:lvl5pPr>
            <a:lvl6pPr marL="2880360" indent="0">
              <a:buNone/>
              <a:defRPr sz="2015" b="1"/>
            </a:lvl6pPr>
            <a:lvl7pPr marL="3456305" indent="0">
              <a:buNone/>
              <a:defRPr sz="2015" b="1"/>
            </a:lvl7pPr>
            <a:lvl8pPr marL="4032250" indent="0">
              <a:buNone/>
              <a:defRPr sz="2015" b="1"/>
            </a:lvl8pPr>
            <a:lvl9pPr marL="4608195" indent="0">
              <a:buNone/>
              <a:defRPr sz="2015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832248" y="3156278"/>
            <a:ext cx="4897708" cy="464241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4" y="576051"/>
            <a:ext cx="3715657" cy="2016178"/>
          </a:xfrm>
        </p:spPr>
        <p:txBody>
          <a:bodyPr anchor="b"/>
          <a:lstStyle>
            <a:lvl1pPr>
              <a:defRPr sz="40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897708" y="1244112"/>
            <a:ext cx="5832247" cy="6140542"/>
          </a:xfrm>
        </p:spPr>
        <p:txBody>
          <a:bodyPr/>
          <a:lstStyle>
            <a:lvl1pPr>
              <a:defRPr sz="4030"/>
            </a:lvl1pPr>
            <a:lvl2pPr>
              <a:defRPr sz="3530"/>
            </a:lvl2pPr>
            <a:lvl3pPr>
              <a:defRPr sz="3025"/>
            </a:lvl3pPr>
            <a:lvl4pPr>
              <a:defRPr sz="2520"/>
            </a:lvl4pPr>
            <a:lvl5pPr>
              <a:defRPr sz="2520"/>
            </a:lvl5pPr>
            <a:lvl6pPr>
              <a:defRPr sz="2520"/>
            </a:lvl6pPr>
            <a:lvl7pPr>
              <a:defRPr sz="2520"/>
            </a:lvl7pPr>
            <a:lvl8pPr>
              <a:defRPr sz="2520"/>
            </a:lvl8pPr>
            <a:lvl9pPr>
              <a:defRPr sz="252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4" y="2592229"/>
            <a:ext cx="3715657" cy="4802425"/>
          </a:xfrm>
        </p:spPr>
        <p:txBody>
          <a:bodyPr/>
          <a:lstStyle>
            <a:lvl1pPr marL="0" indent="0">
              <a:buNone/>
              <a:defRPr sz="2015"/>
            </a:lvl1pPr>
            <a:lvl2pPr marL="575945" indent="0">
              <a:buNone/>
              <a:defRPr sz="1765"/>
            </a:lvl2pPr>
            <a:lvl3pPr marL="1151890" indent="0">
              <a:buNone/>
              <a:defRPr sz="1510"/>
            </a:lvl3pPr>
            <a:lvl4pPr marL="1727835" indent="0">
              <a:buNone/>
              <a:defRPr sz="1260"/>
            </a:lvl4pPr>
            <a:lvl5pPr marL="2304415" indent="0">
              <a:buNone/>
              <a:defRPr sz="1260"/>
            </a:lvl5pPr>
            <a:lvl6pPr marL="2880360" indent="0">
              <a:buNone/>
              <a:defRPr sz="1260"/>
            </a:lvl6pPr>
            <a:lvl7pPr marL="3456305" indent="0">
              <a:buNone/>
              <a:defRPr sz="1260"/>
            </a:lvl7pPr>
            <a:lvl8pPr marL="4032250" indent="0">
              <a:buNone/>
              <a:defRPr sz="1260"/>
            </a:lvl8pPr>
            <a:lvl9pPr marL="4608195" indent="0">
              <a:buNone/>
              <a:defRPr sz="126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93534" y="576051"/>
            <a:ext cx="3715657" cy="2016178"/>
          </a:xfrm>
        </p:spPr>
        <p:txBody>
          <a:bodyPr anchor="b"/>
          <a:lstStyle>
            <a:lvl1pPr>
              <a:defRPr sz="403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897708" y="1244112"/>
            <a:ext cx="5832247" cy="6140542"/>
          </a:xfrm>
        </p:spPr>
        <p:txBody>
          <a:bodyPr anchor="t"/>
          <a:lstStyle>
            <a:lvl1pPr marL="0" indent="0">
              <a:buNone/>
              <a:defRPr sz="4030"/>
            </a:lvl1pPr>
            <a:lvl2pPr marL="575945" indent="0">
              <a:buNone/>
              <a:defRPr sz="3530"/>
            </a:lvl2pPr>
            <a:lvl3pPr marL="1151890" indent="0">
              <a:buNone/>
              <a:defRPr sz="3025"/>
            </a:lvl3pPr>
            <a:lvl4pPr marL="1727835" indent="0">
              <a:buNone/>
              <a:defRPr sz="2520"/>
            </a:lvl4pPr>
            <a:lvl5pPr marL="2304415" indent="0">
              <a:buNone/>
              <a:defRPr sz="2520"/>
            </a:lvl5pPr>
            <a:lvl6pPr marL="2880360" indent="0">
              <a:buNone/>
              <a:defRPr sz="2520"/>
            </a:lvl6pPr>
            <a:lvl7pPr marL="3456305" indent="0">
              <a:buNone/>
              <a:defRPr sz="2520"/>
            </a:lvl7pPr>
            <a:lvl8pPr marL="4032250" indent="0">
              <a:buNone/>
              <a:defRPr sz="2520"/>
            </a:lvl8pPr>
            <a:lvl9pPr marL="4608195" indent="0">
              <a:buNone/>
              <a:defRPr sz="252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93534" y="2592229"/>
            <a:ext cx="3715657" cy="4802425"/>
          </a:xfrm>
        </p:spPr>
        <p:txBody>
          <a:bodyPr/>
          <a:lstStyle>
            <a:lvl1pPr marL="0" indent="0">
              <a:buNone/>
              <a:defRPr sz="2015"/>
            </a:lvl1pPr>
            <a:lvl2pPr marL="575945" indent="0">
              <a:buNone/>
              <a:defRPr sz="1765"/>
            </a:lvl2pPr>
            <a:lvl3pPr marL="1151890" indent="0">
              <a:buNone/>
              <a:defRPr sz="1510"/>
            </a:lvl3pPr>
            <a:lvl4pPr marL="1727835" indent="0">
              <a:buNone/>
              <a:defRPr sz="1260"/>
            </a:lvl4pPr>
            <a:lvl5pPr marL="2304415" indent="0">
              <a:buNone/>
              <a:defRPr sz="1260"/>
            </a:lvl5pPr>
            <a:lvl6pPr marL="2880360" indent="0">
              <a:buNone/>
              <a:defRPr sz="1260"/>
            </a:lvl6pPr>
            <a:lvl7pPr marL="3456305" indent="0">
              <a:buNone/>
              <a:defRPr sz="1260"/>
            </a:lvl7pPr>
            <a:lvl8pPr marL="4032250" indent="0">
              <a:buNone/>
              <a:defRPr sz="1260"/>
            </a:lvl8pPr>
            <a:lvl9pPr marL="4608195" indent="0">
              <a:buNone/>
              <a:defRPr sz="126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92034" y="460043"/>
            <a:ext cx="9936421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92034" y="2300203"/>
            <a:ext cx="9936421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92033" y="8008709"/>
            <a:ext cx="259211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1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FF86F1-A75C-4D9C-AA61-AD6AE0829547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816162" y="8008709"/>
            <a:ext cx="3888165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1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136345" y="8008709"/>
            <a:ext cx="2592110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1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3D3D7B-BB77-4EEF-A47D-A9D042C4D61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151890" rtl="0" eaLnBrk="1" latinLnBrk="0" hangingPunct="1">
        <a:lnSpc>
          <a:spcPct val="90000"/>
        </a:lnSpc>
        <a:spcBef>
          <a:spcPct val="0"/>
        </a:spcBef>
        <a:buNone/>
        <a:defRPr sz="55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8290" indent="-288290" algn="l" defTabSz="1151890" rtl="0" eaLnBrk="1" latinLnBrk="0" hangingPunct="1">
        <a:lnSpc>
          <a:spcPct val="90000"/>
        </a:lnSpc>
        <a:spcBef>
          <a:spcPts val="1260"/>
        </a:spcBef>
        <a:buFont typeface="Arial" panose="020B0604020202020204" pitchFamily="34" charset="0"/>
        <a:buChar char="•"/>
        <a:defRPr sz="3530" kern="1200">
          <a:solidFill>
            <a:schemeClr val="tx1"/>
          </a:solidFill>
          <a:latin typeface="+mn-lt"/>
          <a:ea typeface="+mn-ea"/>
          <a:cs typeface="+mn-cs"/>
        </a:defRPr>
      </a:lvl1pPr>
      <a:lvl2pPr marL="864235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3025" kern="1200">
          <a:solidFill>
            <a:schemeClr val="tx1"/>
          </a:solidFill>
          <a:latin typeface="+mn-lt"/>
          <a:ea typeface="+mn-ea"/>
          <a:cs typeface="+mn-cs"/>
        </a:defRPr>
      </a:lvl2pPr>
      <a:lvl3pPr marL="1440180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3pPr>
      <a:lvl4pPr marL="2016125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4pPr>
      <a:lvl5pPr marL="2592070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5pPr>
      <a:lvl6pPr marL="3168015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6pPr>
      <a:lvl7pPr marL="3743960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7pPr>
      <a:lvl8pPr marL="4319905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8pPr>
      <a:lvl9pPr marL="4896485" indent="-288290" algn="l" defTabSz="1151890" rtl="0" eaLnBrk="1" latinLnBrk="0" hangingPunct="1">
        <a:lnSpc>
          <a:spcPct val="90000"/>
        </a:lnSpc>
        <a:spcBef>
          <a:spcPts val="630"/>
        </a:spcBef>
        <a:buFont typeface="Arial" panose="020B0604020202020204" pitchFamily="34" charset="0"/>
        <a:buChar char="•"/>
        <a:defRPr sz="227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1pPr>
      <a:lvl2pPr marL="575945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2pPr>
      <a:lvl3pPr marL="1151890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3pPr>
      <a:lvl4pPr marL="1727835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4pPr>
      <a:lvl5pPr marL="2304415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5pPr>
      <a:lvl6pPr marL="2880360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6pPr>
      <a:lvl7pPr marL="3456305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7pPr>
      <a:lvl8pPr marL="4032250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8pPr>
      <a:lvl9pPr marL="4608195" algn="l" defTabSz="1151890" rtl="0" eaLnBrk="1" latinLnBrk="0" hangingPunct="1">
        <a:defRPr sz="227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组合 30"/>
          <p:cNvGrpSpPr/>
          <p:nvPr/>
        </p:nvGrpSpPr>
        <p:grpSpPr>
          <a:xfrm>
            <a:off x="342034" y="329480"/>
            <a:ext cx="10836419" cy="7379119"/>
            <a:chOff x="501592" y="-365845"/>
            <a:chExt cx="10836419" cy="7379119"/>
          </a:xfrm>
        </p:grpSpPr>
        <p:pic>
          <p:nvPicPr>
            <p:cNvPr id="32" name="图片 31" descr="图片包含 图表&#10;&#10;描述已自动生成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8224" y="65044"/>
              <a:ext cx="4857379" cy="3501861"/>
            </a:xfrm>
            <a:prstGeom prst="rect">
              <a:avLst/>
            </a:prstGeom>
          </p:spPr>
        </p:pic>
        <p:pic>
          <p:nvPicPr>
            <p:cNvPr id="33" name="图片 32" descr="图片包含 散点图&#10;&#10;描述已自动生成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480632" y="65043"/>
              <a:ext cx="4857379" cy="3501861"/>
            </a:xfrm>
            <a:prstGeom prst="rect">
              <a:avLst/>
            </a:prstGeom>
          </p:spPr>
        </p:pic>
        <p:sp>
          <p:nvSpPr>
            <p:cNvPr id="34" name="文本框 33"/>
            <p:cNvSpPr txBox="1"/>
            <p:nvPr/>
          </p:nvSpPr>
          <p:spPr>
            <a:xfrm>
              <a:off x="1866508" y="-365844"/>
              <a:ext cx="2046533" cy="42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TE-5% </a:t>
              </a:r>
            </a:p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atch-corrected RNA inputs)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7830892" y="-365845"/>
              <a:ext cx="2046533" cy="42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ITE-5% </a:t>
              </a:r>
            </a:p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atch-corrected ADT inputs)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6" name="图片 35" descr="散点图&#10;&#10;描述已自动生成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01592" y="4036115"/>
              <a:ext cx="4934011" cy="2977158"/>
            </a:xfrm>
            <a:prstGeom prst="rect">
              <a:avLst/>
            </a:prstGeom>
          </p:spPr>
        </p:pic>
        <p:pic>
          <p:nvPicPr>
            <p:cNvPr id="37" name="图片 36" descr="图片包含 散点图&#10;&#10;描述已自动生成"/>
            <p:cNvPicPr>
              <a:picLocks noChangeAspect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90845" y="4036115"/>
              <a:ext cx="4934012" cy="2977159"/>
            </a:xfrm>
            <a:prstGeom prst="rect">
              <a:avLst/>
            </a:prstGeom>
          </p:spPr>
        </p:pic>
        <p:sp>
          <p:nvSpPr>
            <p:cNvPr id="38" name="文本框 37"/>
            <p:cNvSpPr txBox="1"/>
            <p:nvPr/>
          </p:nvSpPr>
          <p:spPr>
            <a:xfrm>
              <a:off x="1866508" y="3619230"/>
              <a:ext cx="2046533" cy="42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ltiome-5% </a:t>
              </a:r>
            </a:p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atch-corrected RNA inputs)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7712015" y="3619230"/>
              <a:ext cx="2046532" cy="42989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ltiome-5 % </a:t>
              </a:r>
            </a:p>
            <a:p>
              <a:pPr algn="ctr" defTabSz="914400"/>
              <a:r>
                <a:rPr lang="en-US" altLang="zh-CN" sz="11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(Batch-corrected ATAC inputs)</a:t>
              </a:r>
              <a:endParaRPr lang="zh-CN" altLang="en-US" sz="11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ptos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</Words>
  <Application>Microsoft Office PowerPoint</Application>
  <PresentationFormat>自定义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2</cp:revision>
  <dcterms:created xsi:type="dcterms:W3CDTF">2024-12-11T02:52:00Z</dcterms:created>
  <dcterms:modified xsi:type="dcterms:W3CDTF">2025-06-27T08:42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0.6206</vt:lpwstr>
  </property>
</Properties>
</file>